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4" autoAdjust="0"/>
    <p:restoredTop sz="94660"/>
  </p:normalViewPr>
  <p:slideViewPr>
    <p:cSldViewPr snapToGrid="0">
      <p:cViewPr varScale="1">
        <p:scale>
          <a:sx n="61" d="100"/>
          <a:sy n="61" d="100"/>
        </p:scale>
        <p:origin x="96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4E6081D-6E31-4808-8B30-D3341BD01B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BCC17AEC-5EFE-4F53-A462-BA85C0BBBE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542310D-75AC-4EAE-BF10-9470AA241E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CD539-FE3B-4AC6-AF81-D3CD14FE531A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D448392-F10D-40AC-A801-689DFE188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A7E67F2-E254-4CDF-9753-C75227C93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40E30-5472-4F91-BC87-8249E3B408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6251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8E43F27-CDAA-4631-A752-F122B60E3F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A89A0B1-A879-4A74-ADD5-5FC7E37239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A5B335E-0A2D-499F-BD1F-C51048BBF6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CD539-FE3B-4AC6-AF81-D3CD14FE531A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9ED8ADD-D936-4C54-AEE3-DA036AE4D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0C0432C-30CB-4A47-99D1-A40FF3053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40E30-5472-4F91-BC87-8249E3B408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3169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A6B5CC22-7109-4755-BF89-550C7536A9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78E5141-3148-4683-90EA-B43D1E64CF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4FAFD82-2917-4B03-86FC-C4D2784F24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CD539-FE3B-4AC6-AF81-D3CD14FE531A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A0F559C-B4A6-4825-B38C-AF6F362551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6C08BA8-7BEC-4A0E-94B0-5D929056D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40E30-5472-4F91-BC87-8249E3B408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2975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81D3EA6-CC30-4913-89F7-E139C0368D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EF4DD1A-C990-4EE2-A916-F43B162D86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3AF5C44-A315-4E76-A1A9-5AD1ECD00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CD539-FE3B-4AC6-AF81-D3CD14FE531A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CD5F302-C340-43E2-9B61-F205382FC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5C0EEEC-BD5C-4A05-9139-53C9D49EB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40E30-5472-4F91-BC87-8249E3B408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9018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1F63EDC-F67E-48CA-BE79-FA3266A9EE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0111AC7-1CF4-440E-88FB-2667F4FE5C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80417E0-12F7-4750-83B2-499CA80FE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CD539-FE3B-4AC6-AF81-D3CD14FE531A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93165C8-984E-410B-B5B4-064337850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BF5BE31-357D-423C-A9E8-470AD04C5B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40E30-5472-4F91-BC87-8249E3B408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8642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45FD69A-6E0A-4675-A47A-24227247EB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39B8DE8-62B5-482C-B132-00CD7511E2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4E039D7-493C-49A0-9BEE-B31BAC69A1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FADE14A-2416-4206-B142-287A91392B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CD539-FE3B-4AC6-AF81-D3CD14FE531A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DDB0FF6-A66D-496E-BD55-598AAF2C4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C1D89E0-3FE0-4AB5-82B4-970B10A3F8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40E30-5472-4F91-BC87-8249E3B408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9815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A1D4DFA-A1FB-4FB3-A3F6-BB32DD4337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2CDA2AB-941E-4CD1-972C-9A375DBBBC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847151C-7CB0-4082-A53F-05E4180985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6C4CAD23-821C-4D0A-B88E-FD9F676C23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82F3B4A9-F75A-43E4-9ED4-31633970F3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A32E9493-FD50-4352-8F9A-EEBE2DC9E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CD539-FE3B-4AC6-AF81-D3CD14FE531A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75AB4B95-EF97-4C39-8EE3-4AB4F1CE5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74B35D16-193F-4C99-A69E-E4E422BD6B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40E30-5472-4F91-BC87-8249E3B408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4568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5EE7D8-F9D4-4BB4-8E93-D88F87A419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76AF7260-FC2E-4FED-BC16-CF36527EB2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CD539-FE3B-4AC6-AF81-D3CD14FE531A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8661CED-BC04-4D06-9C3E-150DCADED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021949D0-73B2-4289-858F-DE1584983E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40E30-5472-4F91-BC87-8249E3B408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3368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D09C1B2-46DB-4A15-81FB-F015A3D68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CD539-FE3B-4AC6-AF81-D3CD14FE531A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EBCBCEE-3BF8-4EE3-9A15-107ECA4C1C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8268D20-AF7E-4322-B9B3-6506BFFD69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40E30-5472-4F91-BC87-8249E3B408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1722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A4F37EB-09C6-415E-B6AC-2C48AE6E67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A1FE69A-48D8-4147-9BD9-B57DC34CDC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30E375C-F098-45B0-84FD-34B11DB994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FAA84CD-EB42-4993-9CF7-BD89841CA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CD539-FE3B-4AC6-AF81-D3CD14FE531A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CE6FCBE-235C-4F96-9527-842AE83DED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10EEAA7-6E60-43A4-A1AE-9A3E4D15D6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40E30-5472-4F91-BC87-8249E3B408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9645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FE79592-6F45-4B4C-BD33-5100285195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8F7C30CB-0281-4207-8837-94D4776B90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787B65D-57B5-4ABC-80EA-74EE0B6074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9B86FB3-4753-4DA5-80A7-850856608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CD539-FE3B-4AC6-AF81-D3CD14FE531A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02708C0-3AC3-4265-90F8-E9BAEF35D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6D9A75A-76DD-43E4-9AA5-758D59A3D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40E30-5472-4F91-BC87-8249E3B408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4512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42B1A1E3-43F3-4536-9695-C6234BCE7F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5B4EBF9-38C8-461A-B413-BA607E3D1D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DB9AAE-5997-4ABD-9E18-6AB9233134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CD539-FE3B-4AC6-AF81-D3CD14FE531A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0A6FC98-38D6-4644-BBB6-B63042F7CD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0F814FF-2B04-4A30-BF67-D1E58AEF5B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C40E30-5472-4F91-BC87-8249E3B408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4038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ZoneTexte 32"/>
          <p:cNvSpPr txBox="1"/>
          <p:nvPr/>
        </p:nvSpPr>
        <p:spPr>
          <a:xfrm>
            <a:off x="4431996" y="2904875"/>
            <a:ext cx="4613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>
              <a:defRPr sz="1400" b="1"/>
            </a:lvl1pPr>
          </a:lstStyle>
          <a:p>
            <a:r>
              <a:rPr lang="en-US" dirty="0"/>
              <a:t>Verification of sizes (SDS-PAGE)</a:t>
            </a:r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FE7DFB7-16D2-4637-9734-E9C3126F10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69BF4-5832-4C9B-B6E8-9B5BA1C10234}" type="slidenum">
              <a:rPr lang="fr-FR" smtClean="0"/>
              <a:pPr/>
              <a:t>1</a:t>
            </a:fld>
            <a:endParaRPr lang="fr-FR" dirty="0"/>
          </a:p>
        </p:txBody>
      </p:sp>
      <p:grpSp>
        <p:nvGrpSpPr>
          <p:cNvPr id="8" name="Groupe 7">
            <a:extLst>
              <a:ext uri="{FF2B5EF4-FFF2-40B4-BE49-F238E27FC236}">
                <a16:creationId xmlns:a16="http://schemas.microsoft.com/office/drawing/2014/main" id="{C7AD25B9-D0EC-47DD-ACEF-0F52385EB44F}"/>
              </a:ext>
            </a:extLst>
          </p:cNvPr>
          <p:cNvGrpSpPr>
            <a:grpSpLocks noChangeAspect="1"/>
          </p:cNvGrpSpPr>
          <p:nvPr/>
        </p:nvGrpSpPr>
        <p:grpSpPr>
          <a:xfrm>
            <a:off x="2554015" y="1205993"/>
            <a:ext cx="7124998" cy="4829522"/>
            <a:chOff x="694856" y="356516"/>
            <a:chExt cx="7131080" cy="4833643"/>
          </a:xfrm>
        </p:grpSpPr>
        <p:pic>
          <p:nvPicPr>
            <p:cNvPr id="56" name="Image 55">
              <a:extLst>
                <a:ext uri="{FF2B5EF4-FFF2-40B4-BE49-F238E27FC236}">
                  <a16:creationId xmlns:a16="http://schemas.microsoft.com/office/drawing/2014/main" id="{3857607B-F6CA-47C7-8D8B-773414F164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319" t="16910" r="24049" b="29585"/>
            <a:stretch/>
          </p:blipFill>
          <p:spPr>
            <a:xfrm>
              <a:off x="1324140" y="1688746"/>
              <a:ext cx="6458562" cy="3350475"/>
            </a:xfrm>
            <a:prstGeom prst="rect">
              <a:avLst/>
            </a:prstGeom>
          </p:spPr>
        </p:pic>
        <p:sp>
          <p:nvSpPr>
            <p:cNvPr id="57" name="ZoneTexte 56">
              <a:extLst>
                <a:ext uri="{FF2B5EF4-FFF2-40B4-BE49-F238E27FC236}">
                  <a16:creationId xmlns:a16="http://schemas.microsoft.com/office/drawing/2014/main" id="{923D120B-2CD2-4C60-8B30-02D693274F0D}"/>
                </a:ext>
              </a:extLst>
            </p:cNvPr>
            <p:cNvSpPr txBox="1"/>
            <p:nvPr/>
          </p:nvSpPr>
          <p:spPr>
            <a:xfrm>
              <a:off x="694856" y="1688747"/>
              <a:ext cx="721496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180</a:t>
              </a:r>
            </a:p>
          </p:txBody>
        </p:sp>
        <p:sp>
          <p:nvSpPr>
            <p:cNvPr id="58" name="ZoneTexte 57">
              <a:extLst>
                <a:ext uri="{FF2B5EF4-FFF2-40B4-BE49-F238E27FC236}">
                  <a16:creationId xmlns:a16="http://schemas.microsoft.com/office/drawing/2014/main" id="{B7F53B1A-1284-4795-9CE6-9537AD998F33}"/>
                </a:ext>
              </a:extLst>
            </p:cNvPr>
            <p:cNvSpPr txBox="1"/>
            <p:nvPr/>
          </p:nvSpPr>
          <p:spPr>
            <a:xfrm>
              <a:off x="694856" y="2067998"/>
              <a:ext cx="721496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130</a:t>
              </a:r>
            </a:p>
          </p:txBody>
        </p:sp>
        <p:sp>
          <p:nvSpPr>
            <p:cNvPr id="59" name="ZoneTexte 58">
              <a:extLst>
                <a:ext uri="{FF2B5EF4-FFF2-40B4-BE49-F238E27FC236}">
                  <a16:creationId xmlns:a16="http://schemas.microsoft.com/office/drawing/2014/main" id="{29EAB960-8024-4F33-BE58-2E4E012C4A95}"/>
                </a:ext>
              </a:extLst>
            </p:cNvPr>
            <p:cNvSpPr txBox="1"/>
            <p:nvPr/>
          </p:nvSpPr>
          <p:spPr>
            <a:xfrm>
              <a:off x="694856" y="2580119"/>
              <a:ext cx="721496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100</a:t>
              </a:r>
            </a:p>
          </p:txBody>
        </p:sp>
        <p:sp>
          <p:nvSpPr>
            <p:cNvPr id="60" name="ZoneTexte 59">
              <a:extLst>
                <a:ext uri="{FF2B5EF4-FFF2-40B4-BE49-F238E27FC236}">
                  <a16:creationId xmlns:a16="http://schemas.microsoft.com/office/drawing/2014/main" id="{1D0CCA70-6D1B-42DF-A520-7707FCED0F01}"/>
                </a:ext>
              </a:extLst>
            </p:cNvPr>
            <p:cNvSpPr txBox="1"/>
            <p:nvPr/>
          </p:nvSpPr>
          <p:spPr>
            <a:xfrm>
              <a:off x="811850" y="2976711"/>
              <a:ext cx="594450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70</a:t>
              </a:r>
            </a:p>
          </p:txBody>
        </p:sp>
        <p:sp>
          <p:nvSpPr>
            <p:cNvPr id="61" name="ZoneTexte 60">
              <a:extLst>
                <a:ext uri="{FF2B5EF4-FFF2-40B4-BE49-F238E27FC236}">
                  <a16:creationId xmlns:a16="http://schemas.microsoft.com/office/drawing/2014/main" id="{3114E1EB-E4AB-4A77-9155-C9C74F8D8CE6}"/>
                </a:ext>
              </a:extLst>
            </p:cNvPr>
            <p:cNvSpPr txBox="1"/>
            <p:nvPr/>
          </p:nvSpPr>
          <p:spPr>
            <a:xfrm>
              <a:off x="811850" y="3391923"/>
              <a:ext cx="594450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55</a:t>
              </a:r>
            </a:p>
          </p:txBody>
        </p:sp>
        <p:sp>
          <p:nvSpPr>
            <p:cNvPr id="62" name="ZoneTexte 61">
              <a:extLst>
                <a:ext uri="{FF2B5EF4-FFF2-40B4-BE49-F238E27FC236}">
                  <a16:creationId xmlns:a16="http://schemas.microsoft.com/office/drawing/2014/main" id="{5002C7D3-8B58-4B4A-89A8-8B7E51A31E8A}"/>
                </a:ext>
              </a:extLst>
            </p:cNvPr>
            <p:cNvSpPr txBox="1"/>
            <p:nvPr/>
          </p:nvSpPr>
          <p:spPr>
            <a:xfrm>
              <a:off x="811850" y="3845343"/>
              <a:ext cx="594450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40</a:t>
              </a:r>
            </a:p>
          </p:txBody>
        </p:sp>
        <p:sp>
          <p:nvSpPr>
            <p:cNvPr id="63" name="ZoneTexte 62">
              <a:extLst>
                <a:ext uri="{FF2B5EF4-FFF2-40B4-BE49-F238E27FC236}">
                  <a16:creationId xmlns:a16="http://schemas.microsoft.com/office/drawing/2014/main" id="{E4FBA996-D2DD-427C-9207-BF52600FBEC2}"/>
                </a:ext>
              </a:extLst>
            </p:cNvPr>
            <p:cNvSpPr txBox="1"/>
            <p:nvPr/>
          </p:nvSpPr>
          <p:spPr>
            <a:xfrm>
              <a:off x="811850" y="4295808"/>
              <a:ext cx="594450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35</a:t>
              </a:r>
            </a:p>
          </p:txBody>
        </p:sp>
        <p:sp>
          <p:nvSpPr>
            <p:cNvPr id="64" name="ZoneTexte 63">
              <a:extLst>
                <a:ext uri="{FF2B5EF4-FFF2-40B4-BE49-F238E27FC236}">
                  <a16:creationId xmlns:a16="http://schemas.microsoft.com/office/drawing/2014/main" id="{CBB56B53-17B7-48E7-9C3D-4039E2E3B20A}"/>
                </a:ext>
              </a:extLst>
            </p:cNvPr>
            <p:cNvSpPr txBox="1"/>
            <p:nvPr/>
          </p:nvSpPr>
          <p:spPr>
            <a:xfrm>
              <a:off x="811850" y="4722162"/>
              <a:ext cx="594450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25</a:t>
              </a:r>
            </a:p>
          </p:txBody>
        </p:sp>
        <p:sp>
          <p:nvSpPr>
            <p:cNvPr id="65" name="ZoneTexte 64">
              <a:extLst>
                <a:ext uri="{FF2B5EF4-FFF2-40B4-BE49-F238E27FC236}">
                  <a16:creationId xmlns:a16="http://schemas.microsoft.com/office/drawing/2014/main" id="{0246C45C-F61C-492A-9527-B57D16D26461}"/>
                </a:ext>
              </a:extLst>
            </p:cNvPr>
            <p:cNvSpPr txBox="1"/>
            <p:nvPr/>
          </p:nvSpPr>
          <p:spPr>
            <a:xfrm>
              <a:off x="694856" y="1216113"/>
              <a:ext cx="724448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 err="1"/>
                <a:t>kDa</a:t>
              </a:r>
              <a:endParaRPr lang="fr-FR" sz="1050" dirty="0"/>
            </a:p>
          </p:txBody>
        </p:sp>
        <p:sp>
          <p:nvSpPr>
            <p:cNvPr id="66" name="ZoneTexte 65">
              <a:extLst>
                <a:ext uri="{FF2B5EF4-FFF2-40B4-BE49-F238E27FC236}">
                  <a16:creationId xmlns:a16="http://schemas.microsoft.com/office/drawing/2014/main" id="{8B70ED13-C64B-45BA-A27A-64026B0AEC82}"/>
                </a:ext>
              </a:extLst>
            </p:cNvPr>
            <p:cNvSpPr txBox="1"/>
            <p:nvPr/>
          </p:nvSpPr>
          <p:spPr>
            <a:xfrm rot="18967614">
              <a:off x="2328691" y="1153061"/>
              <a:ext cx="1008084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NP137</a:t>
              </a:r>
            </a:p>
          </p:txBody>
        </p:sp>
        <p:sp>
          <p:nvSpPr>
            <p:cNvPr id="67" name="ZoneTexte 66">
              <a:extLst>
                <a:ext uri="{FF2B5EF4-FFF2-40B4-BE49-F238E27FC236}">
                  <a16:creationId xmlns:a16="http://schemas.microsoft.com/office/drawing/2014/main" id="{C2372F0D-2138-41CF-8805-4E6C397A17B9}"/>
                </a:ext>
              </a:extLst>
            </p:cNvPr>
            <p:cNvSpPr txBox="1"/>
            <p:nvPr/>
          </p:nvSpPr>
          <p:spPr>
            <a:xfrm rot="18967614">
              <a:off x="2911889" y="1284953"/>
              <a:ext cx="677176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 err="1"/>
                <a:t>IgG</a:t>
              </a:r>
              <a:endParaRPr lang="fr-FR" sz="1050" dirty="0"/>
            </a:p>
          </p:txBody>
        </p:sp>
        <p:sp>
          <p:nvSpPr>
            <p:cNvPr id="68" name="ZoneTexte 67">
              <a:extLst>
                <a:ext uri="{FF2B5EF4-FFF2-40B4-BE49-F238E27FC236}">
                  <a16:creationId xmlns:a16="http://schemas.microsoft.com/office/drawing/2014/main" id="{774E9D9A-3AC7-41E8-BD2E-A77930387D83}"/>
                </a:ext>
              </a:extLst>
            </p:cNvPr>
            <p:cNvSpPr txBox="1"/>
            <p:nvPr/>
          </p:nvSpPr>
          <p:spPr>
            <a:xfrm rot="18967614">
              <a:off x="3436230" y="1179617"/>
              <a:ext cx="996266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F(ab’)</a:t>
              </a:r>
              <a:r>
                <a:rPr lang="fr-FR" sz="1050" baseline="-25000" dirty="0"/>
                <a:t>2</a:t>
              </a:r>
            </a:p>
          </p:txBody>
        </p:sp>
        <p:sp>
          <p:nvSpPr>
            <p:cNvPr id="69" name="ZoneTexte 68">
              <a:extLst>
                <a:ext uri="{FF2B5EF4-FFF2-40B4-BE49-F238E27FC236}">
                  <a16:creationId xmlns:a16="http://schemas.microsoft.com/office/drawing/2014/main" id="{2AFCF941-4E15-40AB-B11D-736A5EFDC34B}"/>
                </a:ext>
              </a:extLst>
            </p:cNvPr>
            <p:cNvSpPr txBox="1"/>
            <p:nvPr/>
          </p:nvSpPr>
          <p:spPr>
            <a:xfrm rot="18967614">
              <a:off x="4098114" y="1239985"/>
              <a:ext cx="703769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 err="1"/>
                <a:t>Fab</a:t>
              </a:r>
              <a:endParaRPr lang="fr-FR" sz="1050" baseline="-25000" dirty="0"/>
            </a:p>
          </p:txBody>
        </p:sp>
        <p:sp>
          <p:nvSpPr>
            <p:cNvPr id="105" name="ZoneTexte 104">
              <a:extLst>
                <a:ext uri="{FF2B5EF4-FFF2-40B4-BE49-F238E27FC236}">
                  <a16:creationId xmlns:a16="http://schemas.microsoft.com/office/drawing/2014/main" id="{F65694A3-D746-4CA5-AA4A-D6206F7299BF}"/>
                </a:ext>
              </a:extLst>
            </p:cNvPr>
            <p:cNvSpPr txBox="1"/>
            <p:nvPr/>
          </p:nvSpPr>
          <p:spPr>
            <a:xfrm rot="18967614">
              <a:off x="5269015" y="1139391"/>
              <a:ext cx="1008084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NP137</a:t>
              </a:r>
            </a:p>
          </p:txBody>
        </p:sp>
        <p:sp>
          <p:nvSpPr>
            <p:cNvPr id="106" name="ZoneTexte 105">
              <a:extLst>
                <a:ext uri="{FF2B5EF4-FFF2-40B4-BE49-F238E27FC236}">
                  <a16:creationId xmlns:a16="http://schemas.microsoft.com/office/drawing/2014/main" id="{EF5C25ED-0417-4761-8114-FB27FA5BCB2B}"/>
                </a:ext>
              </a:extLst>
            </p:cNvPr>
            <p:cNvSpPr txBox="1"/>
            <p:nvPr/>
          </p:nvSpPr>
          <p:spPr>
            <a:xfrm rot="18967614">
              <a:off x="5894077" y="1271281"/>
              <a:ext cx="677176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 err="1"/>
                <a:t>IgG</a:t>
              </a:r>
              <a:endParaRPr lang="fr-FR" sz="1050" dirty="0"/>
            </a:p>
          </p:txBody>
        </p:sp>
        <p:sp>
          <p:nvSpPr>
            <p:cNvPr id="107" name="ZoneTexte 106">
              <a:extLst>
                <a:ext uri="{FF2B5EF4-FFF2-40B4-BE49-F238E27FC236}">
                  <a16:creationId xmlns:a16="http://schemas.microsoft.com/office/drawing/2014/main" id="{08DF610D-56E0-4465-A8B7-D30723F5F613}"/>
                </a:ext>
              </a:extLst>
            </p:cNvPr>
            <p:cNvSpPr txBox="1"/>
            <p:nvPr/>
          </p:nvSpPr>
          <p:spPr>
            <a:xfrm rot="18967614">
              <a:off x="6432375" y="1165947"/>
              <a:ext cx="996266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F(ab’)</a:t>
              </a:r>
              <a:r>
                <a:rPr lang="fr-FR" sz="1050" baseline="-25000" dirty="0"/>
                <a:t>2</a:t>
              </a:r>
            </a:p>
          </p:txBody>
        </p:sp>
        <p:sp>
          <p:nvSpPr>
            <p:cNvPr id="108" name="ZoneTexte 107">
              <a:extLst>
                <a:ext uri="{FF2B5EF4-FFF2-40B4-BE49-F238E27FC236}">
                  <a16:creationId xmlns:a16="http://schemas.microsoft.com/office/drawing/2014/main" id="{AA7C8B85-22A9-46D1-AD05-796176199BB9}"/>
                </a:ext>
              </a:extLst>
            </p:cNvPr>
            <p:cNvSpPr txBox="1"/>
            <p:nvPr/>
          </p:nvSpPr>
          <p:spPr>
            <a:xfrm rot="18967614">
              <a:off x="7122167" y="1226312"/>
              <a:ext cx="703769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 err="1"/>
                <a:t>Fab</a:t>
              </a:r>
              <a:endParaRPr lang="fr-FR" sz="1050" baseline="-25000" dirty="0"/>
            </a:p>
          </p:txBody>
        </p:sp>
        <p:sp>
          <p:nvSpPr>
            <p:cNvPr id="109" name="ZoneTexte 108">
              <a:extLst>
                <a:ext uri="{FF2B5EF4-FFF2-40B4-BE49-F238E27FC236}">
                  <a16:creationId xmlns:a16="http://schemas.microsoft.com/office/drawing/2014/main" id="{FDFD1838-7EE6-48EB-B005-850CBC728164}"/>
                </a:ext>
              </a:extLst>
            </p:cNvPr>
            <p:cNvSpPr txBox="1"/>
            <p:nvPr/>
          </p:nvSpPr>
          <p:spPr>
            <a:xfrm>
              <a:off x="2668828" y="356516"/>
              <a:ext cx="2145575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i="1" dirty="0"/>
                <a:t>Non-</a:t>
              </a:r>
              <a:r>
                <a:rPr lang="fr-FR" sz="1050" i="1" dirty="0" err="1"/>
                <a:t>denaturating</a:t>
              </a:r>
              <a:endParaRPr lang="fr-FR" sz="1050" i="1" dirty="0"/>
            </a:p>
          </p:txBody>
        </p:sp>
        <p:sp>
          <p:nvSpPr>
            <p:cNvPr id="110" name="ZoneTexte 109">
              <a:extLst>
                <a:ext uri="{FF2B5EF4-FFF2-40B4-BE49-F238E27FC236}">
                  <a16:creationId xmlns:a16="http://schemas.microsoft.com/office/drawing/2014/main" id="{E1D071FD-7442-43D0-AA99-0A582810CD96}"/>
                </a:ext>
              </a:extLst>
            </p:cNvPr>
            <p:cNvSpPr txBox="1"/>
            <p:nvPr/>
          </p:nvSpPr>
          <p:spPr>
            <a:xfrm>
              <a:off x="5892679" y="356516"/>
              <a:ext cx="1681714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i="1" dirty="0" err="1"/>
                <a:t>Denaturating</a:t>
              </a:r>
              <a:endParaRPr lang="fr-FR" sz="1050" i="1" dirty="0"/>
            </a:p>
          </p:txBody>
        </p:sp>
        <p:sp>
          <p:nvSpPr>
            <p:cNvPr id="111" name="ZoneTexte 110">
              <a:extLst>
                <a:ext uri="{FF2B5EF4-FFF2-40B4-BE49-F238E27FC236}">
                  <a16:creationId xmlns:a16="http://schemas.microsoft.com/office/drawing/2014/main" id="{CE61B1D6-EB18-43E2-B659-AF30E4E18C36}"/>
                </a:ext>
              </a:extLst>
            </p:cNvPr>
            <p:cNvSpPr txBox="1"/>
            <p:nvPr/>
          </p:nvSpPr>
          <p:spPr>
            <a:xfrm>
              <a:off x="3317753" y="735957"/>
              <a:ext cx="1418764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-NODA-GA</a:t>
              </a:r>
            </a:p>
          </p:txBody>
        </p:sp>
        <p:cxnSp>
          <p:nvCxnSpPr>
            <p:cNvPr id="112" name="Connecteur droit 111">
              <a:extLst>
                <a:ext uri="{FF2B5EF4-FFF2-40B4-BE49-F238E27FC236}">
                  <a16:creationId xmlns:a16="http://schemas.microsoft.com/office/drawing/2014/main" id="{52395591-D1A6-4339-92DD-B7D221293E36}"/>
                </a:ext>
              </a:extLst>
            </p:cNvPr>
            <p:cNvCxnSpPr/>
            <p:nvPr/>
          </p:nvCxnSpPr>
          <p:spPr>
            <a:xfrm>
              <a:off x="3184543" y="1094562"/>
              <a:ext cx="1443658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3" name="ZoneTexte 112">
              <a:extLst>
                <a:ext uri="{FF2B5EF4-FFF2-40B4-BE49-F238E27FC236}">
                  <a16:creationId xmlns:a16="http://schemas.microsoft.com/office/drawing/2014/main" id="{962E93D9-5765-4E29-B840-75916927612D}"/>
                </a:ext>
              </a:extLst>
            </p:cNvPr>
            <p:cNvSpPr txBox="1"/>
            <p:nvPr/>
          </p:nvSpPr>
          <p:spPr>
            <a:xfrm>
              <a:off x="6257362" y="735957"/>
              <a:ext cx="1418764" cy="467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-NODA-GA</a:t>
              </a:r>
            </a:p>
          </p:txBody>
        </p:sp>
        <p:cxnSp>
          <p:nvCxnSpPr>
            <p:cNvPr id="114" name="Connecteur droit 113">
              <a:extLst>
                <a:ext uri="{FF2B5EF4-FFF2-40B4-BE49-F238E27FC236}">
                  <a16:creationId xmlns:a16="http://schemas.microsoft.com/office/drawing/2014/main" id="{19E2716B-9F83-47E8-A7C3-C32157B3CEC7}"/>
                </a:ext>
              </a:extLst>
            </p:cNvPr>
            <p:cNvCxnSpPr>
              <a:cxnSpLocks/>
            </p:cNvCxnSpPr>
            <p:nvPr/>
          </p:nvCxnSpPr>
          <p:spPr>
            <a:xfrm>
              <a:off x="6091493" y="1094562"/>
              <a:ext cx="1548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5" name="Connecteur droit 114">
              <a:extLst>
                <a:ext uri="{FF2B5EF4-FFF2-40B4-BE49-F238E27FC236}">
                  <a16:creationId xmlns:a16="http://schemas.microsoft.com/office/drawing/2014/main" id="{5A3956F6-0E8E-4B17-BC4C-9F8E69A47023}"/>
                </a:ext>
              </a:extLst>
            </p:cNvPr>
            <p:cNvCxnSpPr/>
            <p:nvPr/>
          </p:nvCxnSpPr>
          <p:spPr>
            <a:xfrm>
              <a:off x="2503871" y="725848"/>
              <a:ext cx="2124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6" name="Connecteur droit 115">
              <a:extLst>
                <a:ext uri="{FF2B5EF4-FFF2-40B4-BE49-F238E27FC236}">
                  <a16:creationId xmlns:a16="http://schemas.microsoft.com/office/drawing/2014/main" id="{DBCDC37D-09C4-4628-BFAF-7339A44E24FE}"/>
                </a:ext>
              </a:extLst>
            </p:cNvPr>
            <p:cNvCxnSpPr/>
            <p:nvPr/>
          </p:nvCxnSpPr>
          <p:spPr>
            <a:xfrm>
              <a:off x="5515493" y="722353"/>
              <a:ext cx="2124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1660545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</Words>
  <Application>Microsoft Office PowerPoint</Application>
  <PresentationFormat>Grand écran</PresentationFormat>
  <Paragraphs>2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thieu richaud</dc:creator>
  <cp:lastModifiedBy>mathieu richaud</cp:lastModifiedBy>
  <cp:revision>1</cp:revision>
  <dcterms:created xsi:type="dcterms:W3CDTF">2022-10-14T08:26:36Z</dcterms:created>
  <dcterms:modified xsi:type="dcterms:W3CDTF">2022-10-14T08:27:34Z</dcterms:modified>
</cp:coreProperties>
</file>